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327" r:id="rId2"/>
    <p:sldId id="331" r:id="rId3"/>
    <p:sldId id="332" r:id="rId4"/>
    <p:sldId id="325" r:id="rId5"/>
  </p:sldIdLst>
  <p:sldSz cx="9144000" cy="6858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  <a:srgbClr val="FFCCCC"/>
    <a:srgbClr val="385D8A"/>
    <a:srgbClr val="4F81BD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CF1AB2-1976-4502-BF36-3FF5EA218861}" styleName="Mittlere Formatvorlage 4 - Akz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1E4AEA4-8DFA-4A89-87EB-49C32662AFE0}" styleName="Mittlere Formatvorlage 2 - Akz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B301B821-A1FF-4177-AEE7-76D212191A09}" styleName="Mittlere Formatvorlage 1 - Akz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984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E71935-A184-4F6F-A8F6-43D9E523A5B3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84613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5E976C-7103-43FF-B074-6E0359E2008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09771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20C8EA-E934-40FF-A392-61C2CA74D4FF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47738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14875"/>
            <a:ext cx="5486400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4283D9-A13E-4689-9788-44DFE7B513F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2758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4283D9-A13E-4689-9788-44DFE7B513F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6059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1709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7018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309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0198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1825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3635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6340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1885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9294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9127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82345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F414D-8D65-4A3F-8FAA-120BDFE4CD2B}" type="datetimeFigureOut">
              <a:rPr lang="de-DE" smtClean="0"/>
              <a:t>13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74EB0-C2DC-4A43-81AA-21917C95EA2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0183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2283309"/>
              </p:ext>
            </p:extLst>
          </p:nvPr>
        </p:nvGraphicFramePr>
        <p:xfrm>
          <a:off x="1002410" y="1340768"/>
          <a:ext cx="7112000" cy="3238500"/>
        </p:xfrm>
        <a:graphic>
          <a:graphicData uri="http://schemas.openxmlformats.org/drawingml/2006/table">
            <a:tbl>
              <a:tblPr/>
              <a:tblGrid>
                <a:gridCol w="1016000">
                  <a:extLst>
                    <a:ext uri="{9D8B030D-6E8A-4147-A177-3AD203B41FA5}">
                      <a16:colId xmlns:a16="http://schemas.microsoft.com/office/drawing/2014/main" val="2215059875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559190814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1532124474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3594083274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1414240690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3578201651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392374044"/>
                    </a:ext>
                  </a:extLst>
                </a:gridCol>
              </a:tblGrid>
              <a:tr h="190500">
                <a:tc gridSpan="7"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SURVI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05792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variate 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variate 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1749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-5.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-5.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20317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-12.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-18.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64096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-1.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-1.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19547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-4.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43640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-miR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-2.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-2.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7987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-1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-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-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0445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963935"/>
                  </a:ext>
                </a:extLst>
              </a:tr>
              <a:tr h="190500">
                <a:tc gridSpan="7"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GRESSION FREE SURVI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4851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variate 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variate 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69567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-2.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-3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06986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-1.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-1.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7147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-1.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-1.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4357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-5.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06972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-miR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-1.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-1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364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-1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-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-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9608625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99592" y="764704"/>
            <a:ext cx="7214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1: Univariate and Multivariate Cox regression analysi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4677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20079" y="1228849"/>
            <a:ext cx="669674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sz="11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orrelation </a:t>
            </a:r>
            <a:r>
              <a:rPr lang="en-US" sz="1100" dirty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oefficients </a:t>
            </a:r>
            <a:r>
              <a:rPr lang="en-US" sz="11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mong </a:t>
            </a:r>
            <a:r>
              <a:rPr lang="en-US" sz="1100" dirty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the </a:t>
            </a:r>
            <a:r>
              <a:rPr lang="en-US" sz="11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9 </a:t>
            </a:r>
            <a:r>
              <a:rPr lang="en-US" sz="1100" dirty="0" err="1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f</a:t>
            </a:r>
            <a:r>
              <a:rPr lang="en-US" sz="11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-miRNAs are shown where blue depicts a positive correlation and red depicts a negative correlation</a:t>
            </a:r>
            <a:endParaRPr lang="en-US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620079" y="902380"/>
            <a:ext cx="18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682709"/>
              </p:ext>
            </p:extLst>
          </p:nvPr>
        </p:nvGraphicFramePr>
        <p:xfrm>
          <a:off x="683568" y="1844824"/>
          <a:ext cx="6096000" cy="1905000"/>
        </p:xfrm>
        <a:graphic>
          <a:graphicData uri="http://schemas.openxmlformats.org/drawingml/2006/table">
            <a:tbl>
              <a:tblPr/>
              <a:tblGrid>
                <a:gridCol w="609600">
                  <a:extLst>
                    <a:ext uri="{9D8B030D-6E8A-4147-A177-3AD203B41FA5}">
                      <a16:colId xmlns:a16="http://schemas.microsoft.com/office/drawing/2014/main" val="252453490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36592156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1112009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3542561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5088099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1641451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0227381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2190518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83406582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07855545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200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20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4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20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92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1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12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95080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200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898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B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4B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5F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4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4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2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60522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898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84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7D7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7D7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868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B0B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72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79042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20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B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84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1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0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ED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2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0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14650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4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4B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7D7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1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B9D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A8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1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BD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08336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20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5F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7D7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0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B9D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AE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AB7D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D4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00022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92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4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868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A8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AE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C7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2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02489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1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4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B0B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ED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1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F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B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00880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3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2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72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2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AB7D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C7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F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D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83949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.12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0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BD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2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CB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DF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15623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8117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6549884"/>
              </p:ext>
            </p:extLst>
          </p:nvPr>
        </p:nvGraphicFramePr>
        <p:xfrm>
          <a:off x="827584" y="1767299"/>
          <a:ext cx="6057900" cy="3638550"/>
        </p:xfrm>
        <a:graphic>
          <a:graphicData uri="http://schemas.openxmlformats.org/drawingml/2006/table">
            <a:tbl>
              <a:tblPr/>
              <a:tblGrid>
                <a:gridCol w="1170961">
                  <a:extLst>
                    <a:ext uri="{9D8B030D-6E8A-4147-A177-3AD203B41FA5}">
                      <a16:colId xmlns:a16="http://schemas.microsoft.com/office/drawing/2014/main" val="1437919952"/>
                    </a:ext>
                  </a:extLst>
                </a:gridCol>
                <a:gridCol w="790161">
                  <a:extLst>
                    <a:ext uri="{9D8B030D-6E8A-4147-A177-3AD203B41FA5}">
                      <a16:colId xmlns:a16="http://schemas.microsoft.com/office/drawing/2014/main" val="245164940"/>
                    </a:ext>
                  </a:extLst>
                </a:gridCol>
                <a:gridCol w="932961">
                  <a:extLst>
                    <a:ext uri="{9D8B030D-6E8A-4147-A177-3AD203B41FA5}">
                      <a16:colId xmlns:a16="http://schemas.microsoft.com/office/drawing/2014/main" val="277877227"/>
                    </a:ext>
                  </a:extLst>
                </a:gridCol>
                <a:gridCol w="675921">
                  <a:extLst>
                    <a:ext uri="{9D8B030D-6E8A-4147-A177-3AD203B41FA5}">
                      <a16:colId xmlns:a16="http://schemas.microsoft.com/office/drawing/2014/main" val="2973040727"/>
                    </a:ext>
                  </a:extLst>
                </a:gridCol>
                <a:gridCol w="885361">
                  <a:extLst>
                    <a:ext uri="{9D8B030D-6E8A-4147-A177-3AD203B41FA5}">
                      <a16:colId xmlns:a16="http://schemas.microsoft.com/office/drawing/2014/main" val="3732790791"/>
                    </a:ext>
                  </a:extLst>
                </a:gridCol>
                <a:gridCol w="790161">
                  <a:extLst>
                    <a:ext uri="{9D8B030D-6E8A-4147-A177-3AD203B41FA5}">
                      <a16:colId xmlns:a16="http://schemas.microsoft.com/office/drawing/2014/main" val="2477061860"/>
                    </a:ext>
                  </a:extLst>
                </a:gridCol>
                <a:gridCol w="812374">
                  <a:extLst>
                    <a:ext uri="{9D8B030D-6E8A-4147-A177-3AD203B41FA5}">
                      <a16:colId xmlns:a16="http://schemas.microsoft.com/office/drawing/2014/main" val="424251635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307812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idelberg 7-miRs + CA-1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idelberg 7-mi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 7-mi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83004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60724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.vs.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-0.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-0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-0.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92554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.vs.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-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-0.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-0.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34656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28648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04649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23119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4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03020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7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6189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86710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61032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 vs. 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-0.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-0.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8003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.vs.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-0.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36583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27190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40059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2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81681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55762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0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2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300689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83568" y="764704"/>
            <a:ext cx="18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83568" y="1124744"/>
            <a:ext cx="669674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Mean AUCs for each pairwise comparison are presented with 95% confidence intervals (CI) after applying a bootstrapping method with 500 repetitions in three datasets (Heidelberg 7-miRs + CA-125, Heidelberg 7-miRs and external 7-miRs. The mean sensitivity and specificity for each group are presented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8265322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286" y="764192"/>
            <a:ext cx="3705587" cy="249872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44519" y="116632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287D399-1EF0-49E8-BA4B-4FF2274600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9992" y="672015"/>
            <a:ext cx="2376264" cy="263569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88" b="24657"/>
          <a:stretch/>
        </p:blipFill>
        <p:spPr>
          <a:xfrm>
            <a:off x="336510" y="3478426"/>
            <a:ext cx="6925920" cy="211081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332894" y="4488611"/>
            <a:ext cx="554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u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3553373" y="4469951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 (ng/ul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8959" y="548680"/>
            <a:ext cx="4338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8959" y="3140968"/>
            <a:ext cx="35381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                                                     D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9512" y="6093296"/>
            <a:ext cx="8722094" cy="64633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s were dichotimized based on cf-miRNA levels into either low or high groups and progression-free survival (PFS) is depicted as a Kaplan-Meier plot (A). Multivariate cox-regression analysis for PFS is shown as a forset plot (B). The amount of cf-miRNA expressed as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g/µl (C) or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g transformed (D) in the three groups tested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259632" y="5577107"/>
            <a:ext cx="208823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  Benign     Ca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16016" y="5589240"/>
            <a:ext cx="208823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  Benign     Ca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284286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3</TotalTime>
  <Words>514</Words>
  <Application>Microsoft Office PowerPoint</Application>
  <PresentationFormat>On-screen Show (4:3)</PresentationFormat>
  <Paragraphs>311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Larissa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RNAs are globally upregulated in ovarian cancer and correlate with clinical factors</dc:title>
  <dc:creator>Gahlawat, Aoife</dc:creator>
  <cp:lastModifiedBy>Gahlawat, Aoife</cp:lastModifiedBy>
  <cp:revision>437</cp:revision>
  <cp:lastPrinted>2019-10-22T14:36:10Z</cp:lastPrinted>
  <dcterms:created xsi:type="dcterms:W3CDTF">2018-07-19T12:01:01Z</dcterms:created>
  <dcterms:modified xsi:type="dcterms:W3CDTF">2022-07-13T14:53:59Z</dcterms:modified>
</cp:coreProperties>
</file>